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7" autoAdjust="0"/>
    <p:restoredTop sz="94660"/>
  </p:normalViewPr>
  <p:slideViewPr>
    <p:cSldViewPr snapToGrid="0">
      <p:cViewPr varScale="1">
        <p:scale>
          <a:sx n="84" d="100"/>
          <a:sy n="84" d="100"/>
        </p:scale>
        <p:origin x="69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201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622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435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3488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3758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0408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315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3555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6313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402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4036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2B2D5-23D3-4D32-A570-73752E4F5CDC}" type="datetimeFigureOut">
              <a:rPr lang="ko-KR" altLang="en-US" smtClean="0"/>
              <a:t>2017-08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C5C87-D2FB-4425-AB75-B51FAD9C87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0535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>
            <a:extLst>
              <a:ext uri="{FF2B5EF4-FFF2-40B4-BE49-F238E27FC236}">
                <a16:creationId xmlns:a16="http://schemas.microsoft.com/office/drawing/2014/main" id="{E972AA29-28B7-4B94-9CE5-9E64F10B2EE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19506" y="753747"/>
            <a:ext cx="7477127" cy="5591183"/>
            <a:chOff x="1310" y="986"/>
            <a:chExt cx="3140" cy="2348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4F6A9665-CB75-4CDA-9041-96E64085E1C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310" y="986"/>
              <a:ext cx="3140" cy="23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0557ABF4-255B-460B-B52A-7B4A9AB77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0" y="986"/>
              <a:ext cx="3140" cy="234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6">
              <a:extLst>
                <a:ext uri="{FF2B5EF4-FFF2-40B4-BE49-F238E27FC236}">
                  <a16:creationId xmlns:a16="http://schemas.microsoft.com/office/drawing/2014/main" id="{42593E67-EA4C-4716-BC8F-9AA79D537E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3" y="1076"/>
              <a:ext cx="2512" cy="1863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/>
            </a:p>
          </p:txBody>
        </p:sp>
        <p:sp>
          <p:nvSpPr>
            <p:cNvPr id="7" name="Line 7">
              <a:extLst>
                <a:ext uri="{FF2B5EF4-FFF2-40B4-BE49-F238E27FC236}">
                  <a16:creationId xmlns:a16="http://schemas.microsoft.com/office/drawing/2014/main" id="{E2E5F139-BDBD-415F-89E7-1B3FC5A0C5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48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" name="Line 8">
              <a:extLst>
                <a:ext uri="{FF2B5EF4-FFF2-40B4-BE49-F238E27FC236}">
                  <a16:creationId xmlns:a16="http://schemas.microsoft.com/office/drawing/2014/main" id="{05F0E24A-DEFA-4B68-801B-514151E1B1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1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" name="Line 9">
              <a:extLst>
                <a:ext uri="{FF2B5EF4-FFF2-40B4-BE49-F238E27FC236}">
                  <a16:creationId xmlns:a16="http://schemas.microsoft.com/office/drawing/2014/main" id="{7F7F9B5E-EEF2-4DD4-A25F-8F3C99AB57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9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" name="Line 10">
              <a:extLst>
                <a:ext uri="{FF2B5EF4-FFF2-40B4-BE49-F238E27FC236}">
                  <a16:creationId xmlns:a16="http://schemas.microsoft.com/office/drawing/2014/main" id="{19E2592B-98DD-473B-886F-CE14C08556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92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Line 11">
              <a:extLst>
                <a:ext uri="{FF2B5EF4-FFF2-40B4-BE49-F238E27FC236}">
                  <a16:creationId xmlns:a16="http://schemas.microsoft.com/office/drawing/2014/main" id="{01DE967B-1F39-4AD0-B152-48DD65CF9B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1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" name="Line 12">
              <a:extLst>
                <a:ext uri="{FF2B5EF4-FFF2-40B4-BE49-F238E27FC236}">
                  <a16:creationId xmlns:a16="http://schemas.microsoft.com/office/drawing/2014/main" id="{F04A4D71-116D-4689-B2EB-26BF775CFF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54" y="2892"/>
              <a:ext cx="0" cy="4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Rectangle 13">
              <a:extLst>
                <a:ext uri="{FF2B5EF4-FFF2-40B4-BE49-F238E27FC236}">
                  <a16:creationId xmlns:a16="http://schemas.microsoft.com/office/drawing/2014/main" id="{6779D76E-076F-47AD-A7B6-E658CDD5DA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5" y="297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4" name="Rectangle 14">
              <a:extLst>
                <a:ext uri="{FF2B5EF4-FFF2-40B4-BE49-F238E27FC236}">
                  <a16:creationId xmlns:a16="http://schemas.microsoft.com/office/drawing/2014/main" id="{842E6D61-719F-464F-8B52-42190B1D9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6" y="2974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5" name="Rectangle 15">
              <a:extLst>
                <a:ext uri="{FF2B5EF4-FFF2-40B4-BE49-F238E27FC236}">
                  <a16:creationId xmlns:a16="http://schemas.microsoft.com/office/drawing/2014/main" id="{B6857525-4502-46BF-9247-5F7CD4CA9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5" y="2974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6" name="Rectangle 16">
              <a:extLst>
                <a:ext uri="{FF2B5EF4-FFF2-40B4-BE49-F238E27FC236}">
                  <a16:creationId xmlns:a16="http://schemas.microsoft.com/office/drawing/2014/main" id="{CB356B03-4155-4F35-B64E-65EE1A4F84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8" y="2974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7" name="Rectangle 17">
              <a:extLst>
                <a:ext uri="{FF2B5EF4-FFF2-40B4-BE49-F238E27FC236}">
                  <a16:creationId xmlns:a16="http://schemas.microsoft.com/office/drawing/2014/main" id="{68914F4E-19D5-4A88-96CF-C1E2C044BF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7" y="2974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8" name="Rectangle 18">
              <a:extLst>
                <a:ext uri="{FF2B5EF4-FFF2-40B4-BE49-F238E27FC236}">
                  <a16:creationId xmlns:a16="http://schemas.microsoft.com/office/drawing/2014/main" id="{0B7ED6D5-C566-4F19-AF44-142D7C1B9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0" y="2974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19" name="Line 19">
              <a:extLst>
                <a:ext uri="{FF2B5EF4-FFF2-40B4-BE49-F238E27FC236}">
                  <a16:creationId xmlns:a16="http://schemas.microsoft.com/office/drawing/2014/main" id="{2024E7E7-1341-46E5-8887-DC38B7E5D9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1118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" name="Line 20">
              <a:extLst>
                <a:ext uri="{FF2B5EF4-FFF2-40B4-BE49-F238E27FC236}">
                  <a16:creationId xmlns:a16="http://schemas.microsoft.com/office/drawing/2014/main" id="{7C906255-EEE0-45AE-A901-3FA1D52DC7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1313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" name="Line 22">
              <a:extLst>
                <a:ext uri="{FF2B5EF4-FFF2-40B4-BE49-F238E27FC236}">
                  <a16:creationId xmlns:a16="http://schemas.microsoft.com/office/drawing/2014/main" id="{708965A3-7FEA-42B7-91E0-A0BBE5BC59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1509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" name="Line 24">
              <a:extLst>
                <a:ext uri="{FF2B5EF4-FFF2-40B4-BE49-F238E27FC236}">
                  <a16:creationId xmlns:a16="http://schemas.microsoft.com/office/drawing/2014/main" id="{1D8C296A-14DD-4684-A600-ADCBE1A10D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1705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" name="Line 26">
              <a:extLst>
                <a:ext uri="{FF2B5EF4-FFF2-40B4-BE49-F238E27FC236}">
                  <a16:creationId xmlns:a16="http://schemas.microsoft.com/office/drawing/2014/main" id="{B87113CF-C02A-42A0-8003-22E198130A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1900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Line 28">
              <a:extLst>
                <a:ext uri="{FF2B5EF4-FFF2-40B4-BE49-F238E27FC236}">
                  <a16:creationId xmlns:a16="http://schemas.microsoft.com/office/drawing/2014/main" id="{9E3A00A7-D905-430C-AABD-732ED1A353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2092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Line 30">
              <a:extLst>
                <a:ext uri="{FF2B5EF4-FFF2-40B4-BE49-F238E27FC236}">
                  <a16:creationId xmlns:a16="http://schemas.microsoft.com/office/drawing/2014/main" id="{2CC31121-E231-4F55-A21C-72D54DA4DA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2288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" name="Line 32">
              <a:extLst>
                <a:ext uri="{FF2B5EF4-FFF2-40B4-BE49-F238E27FC236}">
                  <a16:creationId xmlns:a16="http://schemas.microsoft.com/office/drawing/2014/main" id="{5CCF09E9-AD5C-472F-A950-5A5EC2A80D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2484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Line 34">
              <a:extLst>
                <a:ext uri="{FF2B5EF4-FFF2-40B4-BE49-F238E27FC236}">
                  <a16:creationId xmlns:a16="http://schemas.microsoft.com/office/drawing/2014/main" id="{5297F45D-0A4E-47F0-8003-95F7C53FE2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2679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Line 36">
              <a:extLst>
                <a:ext uri="{FF2B5EF4-FFF2-40B4-BE49-F238E27FC236}">
                  <a16:creationId xmlns:a16="http://schemas.microsoft.com/office/drawing/2014/main" id="{69C79B7C-D4C3-4680-BF55-C8C6DC2CD7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3" y="2888"/>
              <a:ext cx="5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Rectangle 38">
              <a:extLst>
                <a:ext uri="{FF2B5EF4-FFF2-40B4-BE49-F238E27FC236}">
                  <a16:creationId xmlns:a16="http://schemas.microsoft.com/office/drawing/2014/main" id="{034D7F9B-23B5-4737-9718-87BACCE0A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2822"/>
              <a:ext cx="10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-40</a:t>
              </a:r>
            </a:p>
          </p:txBody>
        </p:sp>
        <p:sp>
          <p:nvSpPr>
            <p:cNvPr id="40" name="Rectangle 40">
              <a:extLst>
                <a:ext uri="{FF2B5EF4-FFF2-40B4-BE49-F238E27FC236}">
                  <a16:creationId xmlns:a16="http://schemas.microsoft.com/office/drawing/2014/main" id="{52D1610F-2277-4859-8D23-E966F3EA6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9" y="2430"/>
              <a:ext cx="11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2">
              <a:extLst>
                <a:ext uri="{FF2B5EF4-FFF2-40B4-BE49-F238E27FC236}">
                  <a16:creationId xmlns:a16="http://schemas.microsoft.com/office/drawing/2014/main" id="{0394B730-BAC9-404E-A7A5-9168B54D1A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1" y="2039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45" name="Rectangle 45">
              <a:extLst>
                <a:ext uri="{FF2B5EF4-FFF2-40B4-BE49-F238E27FC236}">
                  <a16:creationId xmlns:a16="http://schemas.microsoft.com/office/drawing/2014/main" id="{6F06E882-ED18-4906-AD61-A690597B92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8" y="1456"/>
              <a:ext cx="12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8" name="Rectangle 48">
              <a:extLst>
                <a:ext uri="{FF2B5EF4-FFF2-40B4-BE49-F238E27FC236}">
                  <a16:creationId xmlns:a16="http://schemas.microsoft.com/office/drawing/2014/main" id="{A46D0E84-76B1-4925-8485-7874FD53E8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3" y="1076"/>
              <a:ext cx="2512" cy="1863"/>
            </a:xfrm>
            <a:prstGeom prst="rect">
              <a:avLst/>
            </a:prstGeom>
            <a:noFill/>
            <a:ln w="19050">
              <a:noFill/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Rectangle 49">
              <a:extLst>
                <a:ext uri="{FF2B5EF4-FFF2-40B4-BE49-F238E27FC236}">
                  <a16:creationId xmlns:a16="http://schemas.microsoft.com/office/drawing/2014/main" id="{DD921245-8BDE-4F6A-9F36-2FBF521299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5" y="3135"/>
              <a:ext cx="1476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1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Mean</a:t>
              </a: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of LVMI </a:t>
              </a:r>
              <a:r>
                <a:rPr kumimoji="0" lang="ko-KR" altLang="ko-KR" sz="1400" b="1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by</a:t>
              </a: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ECHO and LVMI </a:t>
              </a:r>
              <a:r>
                <a:rPr kumimoji="0" lang="ko-KR" altLang="ko-KR" sz="1400" b="1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by</a:t>
              </a: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CMR</a:t>
              </a:r>
            </a:p>
          </p:txBody>
        </p:sp>
        <p:sp>
          <p:nvSpPr>
            <p:cNvPr id="50" name="Rectangle 50">
              <a:extLst>
                <a:ext uri="{FF2B5EF4-FFF2-40B4-BE49-F238E27FC236}">
                  <a16:creationId xmlns:a16="http://schemas.microsoft.com/office/drawing/2014/main" id="{D9C882A1-50E8-4795-AA57-1781AD60C3A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001" y="2040"/>
              <a:ext cx="106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LVMI </a:t>
              </a:r>
              <a:r>
                <a:rPr kumimoji="0" lang="ko-KR" altLang="ko-KR" sz="1400" b="1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by</a:t>
              </a: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ECHO - LVMI </a:t>
              </a:r>
              <a:r>
                <a:rPr kumimoji="0" lang="ko-KR" altLang="ko-KR" sz="1400" b="1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by</a:t>
              </a:r>
              <a:r>
                <a:rPr kumimoji="0" lang="ko-KR" altLang="ko-KR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CMR</a:t>
              </a:r>
            </a:p>
          </p:txBody>
        </p:sp>
        <p:sp>
          <p:nvSpPr>
            <p:cNvPr id="51" name="Oval 51">
              <a:extLst>
                <a:ext uri="{FF2B5EF4-FFF2-40B4-BE49-F238E27FC236}">
                  <a16:creationId xmlns:a16="http://schemas.microsoft.com/office/drawing/2014/main" id="{A7FB68EC-32EF-4FD2-87F7-FB6D5CFEF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0" y="152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Oval 52">
              <a:extLst>
                <a:ext uri="{FF2B5EF4-FFF2-40B4-BE49-F238E27FC236}">
                  <a16:creationId xmlns:a16="http://schemas.microsoft.com/office/drawing/2014/main" id="{3BC1C738-EC10-4B86-8407-FBB309C2D3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0" y="1855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" name="Oval 53">
              <a:extLst>
                <a:ext uri="{FF2B5EF4-FFF2-40B4-BE49-F238E27FC236}">
                  <a16:creationId xmlns:a16="http://schemas.microsoft.com/office/drawing/2014/main" id="{D50D71B5-CC83-4C1E-808A-173BD22458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" y="2180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Oval 54">
              <a:extLst>
                <a:ext uri="{FF2B5EF4-FFF2-40B4-BE49-F238E27FC236}">
                  <a16:creationId xmlns:a16="http://schemas.microsoft.com/office/drawing/2014/main" id="{0AAAE63F-1D6C-4699-BA75-E53FA5295C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8" y="1213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" name="Oval 55">
              <a:extLst>
                <a:ext uri="{FF2B5EF4-FFF2-40B4-BE49-F238E27FC236}">
                  <a16:creationId xmlns:a16="http://schemas.microsoft.com/office/drawing/2014/main" id="{FEAAD714-DA4C-4B34-8735-128E33842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" y="2086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Oval 56">
              <a:extLst>
                <a:ext uri="{FF2B5EF4-FFF2-40B4-BE49-F238E27FC236}">
                  <a16:creationId xmlns:a16="http://schemas.microsoft.com/office/drawing/2014/main" id="{1FE8015B-7BD2-4CEE-B71E-17F7A13C7B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2" y="2027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7" name="Oval 57">
              <a:extLst>
                <a:ext uri="{FF2B5EF4-FFF2-40B4-BE49-F238E27FC236}">
                  <a16:creationId xmlns:a16="http://schemas.microsoft.com/office/drawing/2014/main" id="{DDE23674-3951-4ABD-B56B-16D4B18E7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8" y="190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8" name="Oval 58">
              <a:extLst>
                <a:ext uri="{FF2B5EF4-FFF2-40B4-BE49-F238E27FC236}">
                  <a16:creationId xmlns:a16="http://schemas.microsoft.com/office/drawing/2014/main" id="{E62C3FBC-1FE1-487F-89D3-929297C4A9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9" y="2297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Oval 59">
              <a:extLst>
                <a:ext uri="{FF2B5EF4-FFF2-40B4-BE49-F238E27FC236}">
                  <a16:creationId xmlns:a16="http://schemas.microsoft.com/office/drawing/2014/main" id="{DB061301-B84E-471A-A769-A862FA9953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9" y="1808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Oval 60">
              <a:extLst>
                <a:ext uri="{FF2B5EF4-FFF2-40B4-BE49-F238E27FC236}">
                  <a16:creationId xmlns:a16="http://schemas.microsoft.com/office/drawing/2014/main" id="{04E20048-F845-4C60-A6E7-77C873C873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5" y="2105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1" name="Oval 61">
              <a:extLst>
                <a:ext uri="{FF2B5EF4-FFF2-40B4-BE49-F238E27FC236}">
                  <a16:creationId xmlns:a16="http://schemas.microsoft.com/office/drawing/2014/main" id="{91B62B21-855D-4B0E-B4B1-97D560851E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1" y="1917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2" name="Oval 62">
              <a:extLst>
                <a:ext uri="{FF2B5EF4-FFF2-40B4-BE49-F238E27FC236}">
                  <a16:creationId xmlns:a16="http://schemas.microsoft.com/office/drawing/2014/main" id="{05559103-17E2-4C7C-9E7D-1A572A1BD3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" y="2117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3" name="Oval 63">
              <a:extLst>
                <a:ext uri="{FF2B5EF4-FFF2-40B4-BE49-F238E27FC236}">
                  <a16:creationId xmlns:a16="http://schemas.microsoft.com/office/drawing/2014/main" id="{68631292-41F5-4FF7-A7D6-FE7D25BD61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0" y="1988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4" name="Oval 64">
              <a:extLst>
                <a:ext uri="{FF2B5EF4-FFF2-40B4-BE49-F238E27FC236}">
                  <a16:creationId xmlns:a16="http://schemas.microsoft.com/office/drawing/2014/main" id="{A7D829FA-9450-429F-8027-3443E585A1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3" y="233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5" name="Oval 65">
              <a:extLst>
                <a:ext uri="{FF2B5EF4-FFF2-40B4-BE49-F238E27FC236}">
                  <a16:creationId xmlns:a16="http://schemas.microsoft.com/office/drawing/2014/main" id="{82F1AC91-6C2B-4DA2-BFF5-402A9D1806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8" y="2301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6" name="Oval 66">
              <a:extLst>
                <a:ext uri="{FF2B5EF4-FFF2-40B4-BE49-F238E27FC236}">
                  <a16:creationId xmlns:a16="http://schemas.microsoft.com/office/drawing/2014/main" id="{7B668E1B-918E-4A28-AE97-AFA5B8DD6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" y="1890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7" name="Oval 67">
              <a:extLst>
                <a:ext uri="{FF2B5EF4-FFF2-40B4-BE49-F238E27FC236}">
                  <a16:creationId xmlns:a16="http://schemas.microsoft.com/office/drawing/2014/main" id="{0F9E23CB-6994-4DE7-8CCF-F37B7EEB10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" y="2113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8" name="Oval 68">
              <a:extLst>
                <a:ext uri="{FF2B5EF4-FFF2-40B4-BE49-F238E27FC236}">
                  <a16:creationId xmlns:a16="http://schemas.microsoft.com/office/drawing/2014/main" id="{5D4C2453-62AA-45F6-A813-2260991089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2297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9" name="Oval 69">
              <a:extLst>
                <a:ext uri="{FF2B5EF4-FFF2-40B4-BE49-F238E27FC236}">
                  <a16:creationId xmlns:a16="http://schemas.microsoft.com/office/drawing/2014/main" id="{BBC08A73-EB94-4B7A-992A-939A9A8AA3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1710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/>
            </a:p>
          </p:txBody>
        </p:sp>
        <p:sp>
          <p:nvSpPr>
            <p:cNvPr id="70" name="Oval 70">
              <a:extLst>
                <a:ext uri="{FF2B5EF4-FFF2-40B4-BE49-F238E27FC236}">
                  <a16:creationId xmlns:a16="http://schemas.microsoft.com/office/drawing/2014/main" id="{9F11EEE5-B9C6-4EF8-AA2D-3EEE347B95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8" y="1820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1" name="Oval 71">
              <a:extLst>
                <a:ext uri="{FF2B5EF4-FFF2-40B4-BE49-F238E27FC236}">
                  <a16:creationId xmlns:a16="http://schemas.microsoft.com/office/drawing/2014/main" id="{6A0178CB-5261-4D8A-956E-B9AEB95E9A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4" y="1941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Oval 72">
              <a:extLst>
                <a:ext uri="{FF2B5EF4-FFF2-40B4-BE49-F238E27FC236}">
                  <a16:creationId xmlns:a16="http://schemas.microsoft.com/office/drawing/2014/main" id="{CC3EC3DC-375C-4609-B7D2-03ADEA8C23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" y="2078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3" name="Oval 73">
              <a:extLst>
                <a:ext uri="{FF2B5EF4-FFF2-40B4-BE49-F238E27FC236}">
                  <a16:creationId xmlns:a16="http://schemas.microsoft.com/office/drawing/2014/main" id="{82678F42-1215-414C-8E59-8E65DE539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7" y="2438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Oval 74">
              <a:extLst>
                <a:ext uri="{FF2B5EF4-FFF2-40B4-BE49-F238E27FC236}">
                  <a16:creationId xmlns:a16="http://schemas.microsoft.com/office/drawing/2014/main" id="{10F69E93-9361-46A2-8E77-6DAEEC5E97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" y="1514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5" name="Oval 75">
              <a:extLst>
                <a:ext uri="{FF2B5EF4-FFF2-40B4-BE49-F238E27FC236}">
                  <a16:creationId xmlns:a16="http://schemas.microsoft.com/office/drawing/2014/main" id="{284D3141-749D-4BEE-BBB5-61A96CA54C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4" y="2547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6" name="Oval 76">
              <a:extLst>
                <a:ext uri="{FF2B5EF4-FFF2-40B4-BE49-F238E27FC236}">
                  <a16:creationId xmlns:a16="http://schemas.microsoft.com/office/drawing/2014/main" id="{1A1CAC82-93AF-4034-927E-E3B4A88A6A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5" y="1917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7" name="Oval 77">
              <a:extLst>
                <a:ext uri="{FF2B5EF4-FFF2-40B4-BE49-F238E27FC236}">
                  <a16:creationId xmlns:a16="http://schemas.microsoft.com/office/drawing/2014/main" id="{D5C82650-5C1F-40C6-9046-9963FAC692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5" y="1820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Oval 78">
              <a:extLst>
                <a:ext uri="{FF2B5EF4-FFF2-40B4-BE49-F238E27FC236}">
                  <a16:creationId xmlns:a16="http://schemas.microsoft.com/office/drawing/2014/main" id="{84B020CC-8400-4B8B-82A4-24E9DDA22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" y="244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Oval 79">
              <a:extLst>
                <a:ext uri="{FF2B5EF4-FFF2-40B4-BE49-F238E27FC236}">
                  <a16:creationId xmlns:a16="http://schemas.microsoft.com/office/drawing/2014/main" id="{F27856AA-C329-4675-8F9B-02402B58F9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" y="1796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" name="Oval 80">
              <a:extLst>
                <a:ext uri="{FF2B5EF4-FFF2-40B4-BE49-F238E27FC236}">
                  <a16:creationId xmlns:a16="http://schemas.microsoft.com/office/drawing/2014/main" id="{3313251A-1B16-4096-B4D8-C27D0997B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1" y="215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Oval 81">
              <a:extLst>
                <a:ext uri="{FF2B5EF4-FFF2-40B4-BE49-F238E27FC236}">
                  <a16:creationId xmlns:a16="http://schemas.microsoft.com/office/drawing/2014/main" id="{23CFFB81-D1AC-4494-A590-C7653E4CDC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1" y="1777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" name="Oval 82">
              <a:extLst>
                <a:ext uri="{FF2B5EF4-FFF2-40B4-BE49-F238E27FC236}">
                  <a16:creationId xmlns:a16="http://schemas.microsoft.com/office/drawing/2014/main" id="{8CA905B3-7726-4197-B637-C7CB43EBD4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3" y="2148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Oval 83">
              <a:extLst>
                <a:ext uri="{FF2B5EF4-FFF2-40B4-BE49-F238E27FC236}">
                  <a16:creationId xmlns:a16="http://schemas.microsoft.com/office/drawing/2014/main" id="{4E0E57E5-0DC0-4E0F-A4DA-864E837C0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6" y="1143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Oval 84">
              <a:extLst>
                <a:ext uri="{FF2B5EF4-FFF2-40B4-BE49-F238E27FC236}">
                  <a16:creationId xmlns:a16="http://schemas.microsoft.com/office/drawing/2014/main" id="{10D337E5-75D1-48CE-A6F2-AD0E6FA4BB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3" y="1847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" name="Oval 85">
              <a:extLst>
                <a:ext uri="{FF2B5EF4-FFF2-40B4-BE49-F238E27FC236}">
                  <a16:creationId xmlns:a16="http://schemas.microsoft.com/office/drawing/2014/main" id="{20F82682-9759-439E-B162-A327705CC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2129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" name="Oval 86">
              <a:extLst>
                <a:ext uri="{FF2B5EF4-FFF2-40B4-BE49-F238E27FC236}">
                  <a16:creationId xmlns:a16="http://schemas.microsoft.com/office/drawing/2014/main" id="{A4261DD2-6FFC-4998-9266-B9F9601E0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5" y="2371"/>
              <a:ext cx="36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" name="Oval 87">
              <a:extLst>
                <a:ext uri="{FF2B5EF4-FFF2-40B4-BE49-F238E27FC236}">
                  <a16:creationId xmlns:a16="http://schemas.microsoft.com/office/drawing/2014/main" id="{83A38CE3-084E-4FCD-A0CE-4BF4D07AC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2" y="2027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" name="Oval 88">
              <a:extLst>
                <a:ext uri="{FF2B5EF4-FFF2-40B4-BE49-F238E27FC236}">
                  <a16:creationId xmlns:a16="http://schemas.microsoft.com/office/drawing/2014/main" id="{30D1747B-AEEA-42CD-98AD-F8E1BE5621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1" y="2121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Oval 89">
              <a:extLst>
                <a:ext uri="{FF2B5EF4-FFF2-40B4-BE49-F238E27FC236}">
                  <a16:creationId xmlns:a16="http://schemas.microsoft.com/office/drawing/2014/main" id="{2DD6B5EC-2A62-42E2-A9CB-50A87B8216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" y="1898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Oval 90">
              <a:extLst>
                <a:ext uri="{FF2B5EF4-FFF2-40B4-BE49-F238E27FC236}">
                  <a16:creationId xmlns:a16="http://schemas.microsoft.com/office/drawing/2014/main" id="{1DE9F9FB-E319-40A5-A217-5D6142815F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0" y="2266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" name="Oval 91">
              <a:extLst>
                <a:ext uri="{FF2B5EF4-FFF2-40B4-BE49-F238E27FC236}">
                  <a16:creationId xmlns:a16="http://schemas.microsoft.com/office/drawing/2014/main" id="{F7C022F9-D530-49C5-A877-7FAF1C48AE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2" y="2039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Oval 92">
              <a:extLst>
                <a:ext uri="{FF2B5EF4-FFF2-40B4-BE49-F238E27FC236}">
                  <a16:creationId xmlns:a16="http://schemas.microsoft.com/office/drawing/2014/main" id="{168D7F2D-54A1-48E1-B5A3-83498A80B7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3" y="2457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" name="Oval 93">
              <a:extLst>
                <a:ext uri="{FF2B5EF4-FFF2-40B4-BE49-F238E27FC236}">
                  <a16:creationId xmlns:a16="http://schemas.microsoft.com/office/drawing/2014/main" id="{54EE42B2-3BF5-404D-B15B-BCB0C4D4A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8" y="2281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Oval 94">
              <a:extLst>
                <a:ext uri="{FF2B5EF4-FFF2-40B4-BE49-F238E27FC236}">
                  <a16:creationId xmlns:a16="http://schemas.microsoft.com/office/drawing/2014/main" id="{E8D1D244-9CD5-4CDF-A630-F5C985CA3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3" y="2559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" name="Oval 95">
              <a:extLst>
                <a:ext uri="{FF2B5EF4-FFF2-40B4-BE49-F238E27FC236}">
                  <a16:creationId xmlns:a16="http://schemas.microsoft.com/office/drawing/2014/main" id="{3374FCCF-295B-4819-9FB1-E5B2597B85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3" y="2270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" name="Oval 96">
              <a:extLst>
                <a:ext uri="{FF2B5EF4-FFF2-40B4-BE49-F238E27FC236}">
                  <a16:creationId xmlns:a16="http://schemas.microsoft.com/office/drawing/2014/main" id="{B173CBC8-FA24-4C85-AB75-859FC2587B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5" y="2117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" name="Oval 97">
              <a:extLst>
                <a:ext uri="{FF2B5EF4-FFF2-40B4-BE49-F238E27FC236}">
                  <a16:creationId xmlns:a16="http://schemas.microsoft.com/office/drawing/2014/main" id="{9C9516A7-FD2E-4795-A084-C2E0D1CABF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4" y="1581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" name="Oval 98">
              <a:extLst>
                <a:ext uri="{FF2B5EF4-FFF2-40B4-BE49-F238E27FC236}">
                  <a16:creationId xmlns:a16="http://schemas.microsoft.com/office/drawing/2014/main" id="{C0439E01-B6F6-46C6-8447-C6ED76D08B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8" y="2184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Oval 99">
              <a:extLst>
                <a:ext uri="{FF2B5EF4-FFF2-40B4-BE49-F238E27FC236}">
                  <a16:creationId xmlns:a16="http://schemas.microsoft.com/office/drawing/2014/main" id="{789C3753-4B39-459D-8320-08C28B3469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1" y="2563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Oval 100">
              <a:extLst>
                <a:ext uri="{FF2B5EF4-FFF2-40B4-BE49-F238E27FC236}">
                  <a16:creationId xmlns:a16="http://schemas.microsoft.com/office/drawing/2014/main" id="{0ADB9850-17D0-498C-940D-73D4362F3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1" y="2050"/>
              <a:ext cx="36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Oval 101">
              <a:extLst>
                <a:ext uri="{FF2B5EF4-FFF2-40B4-BE49-F238E27FC236}">
                  <a16:creationId xmlns:a16="http://schemas.microsoft.com/office/drawing/2014/main" id="{994F3A7D-B318-497E-AE2E-2AD34F806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1" y="199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Oval 102">
              <a:extLst>
                <a:ext uri="{FF2B5EF4-FFF2-40B4-BE49-F238E27FC236}">
                  <a16:creationId xmlns:a16="http://schemas.microsoft.com/office/drawing/2014/main" id="{171E66F9-8E60-4A14-B2AC-F653C76986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8" y="2043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Oval 103">
              <a:extLst>
                <a:ext uri="{FF2B5EF4-FFF2-40B4-BE49-F238E27FC236}">
                  <a16:creationId xmlns:a16="http://schemas.microsoft.com/office/drawing/2014/main" id="{AA0C014D-1EB7-45AB-8956-4ED674CF50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8" y="2101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" name="Oval 104">
              <a:extLst>
                <a:ext uri="{FF2B5EF4-FFF2-40B4-BE49-F238E27FC236}">
                  <a16:creationId xmlns:a16="http://schemas.microsoft.com/office/drawing/2014/main" id="{4BC1E4C0-5A3A-4E58-B486-1B543217F5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2" y="2156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Oval 105">
              <a:extLst>
                <a:ext uri="{FF2B5EF4-FFF2-40B4-BE49-F238E27FC236}">
                  <a16:creationId xmlns:a16="http://schemas.microsoft.com/office/drawing/2014/main" id="{3C81AFAF-CD7A-4941-8EA7-926FC20AE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1" y="2563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Oval 106">
              <a:extLst>
                <a:ext uri="{FF2B5EF4-FFF2-40B4-BE49-F238E27FC236}">
                  <a16:creationId xmlns:a16="http://schemas.microsoft.com/office/drawing/2014/main" id="{6472FB79-CEB7-41BE-AC01-E13ABC6227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" y="2050"/>
              <a:ext cx="36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" name="Oval 107">
              <a:extLst>
                <a:ext uri="{FF2B5EF4-FFF2-40B4-BE49-F238E27FC236}">
                  <a16:creationId xmlns:a16="http://schemas.microsoft.com/office/drawing/2014/main" id="{916F7395-9201-4663-8D75-9357209AA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8" y="2227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" name="Oval 108">
              <a:extLst>
                <a:ext uri="{FF2B5EF4-FFF2-40B4-BE49-F238E27FC236}">
                  <a16:creationId xmlns:a16="http://schemas.microsoft.com/office/drawing/2014/main" id="{920A91B8-4900-4D1D-8DAB-43A44393D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" y="2152"/>
              <a:ext cx="35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Oval 109">
              <a:extLst>
                <a:ext uri="{FF2B5EF4-FFF2-40B4-BE49-F238E27FC236}">
                  <a16:creationId xmlns:a16="http://schemas.microsoft.com/office/drawing/2014/main" id="{86EBC722-6C52-4ED0-9EB0-F9C55C4C43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6" y="2230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Oval 110">
              <a:extLst>
                <a:ext uri="{FF2B5EF4-FFF2-40B4-BE49-F238E27FC236}">
                  <a16:creationId xmlns:a16="http://schemas.microsoft.com/office/drawing/2014/main" id="{19B65D4C-1CAE-4D9F-9133-A7E2E05F8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" y="2113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Oval 111">
              <a:extLst>
                <a:ext uri="{FF2B5EF4-FFF2-40B4-BE49-F238E27FC236}">
                  <a16:creationId xmlns:a16="http://schemas.microsoft.com/office/drawing/2014/main" id="{BE0067E3-DF39-4A73-81F6-C01BF2833F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5" y="2277"/>
              <a:ext cx="35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Oval 112">
              <a:extLst>
                <a:ext uri="{FF2B5EF4-FFF2-40B4-BE49-F238E27FC236}">
                  <a16:creationId xmlns:a16="http://schemas.microsoft.com/office/drawing/2014/main" id="{C5890086-195B-4F13-AD61-C96812814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2352"/>
              <a:ext cx="36" cy="35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" name="Oval 113">
              <a:extLst>
                <a:ext uri="{FF2B5EF4-FFF2-40B4-BE49-F238E27FC236}">
                  <a16:creationId xmlns:a16="http://schemas.microsoft.com/office/drawing/2014/main" id="{24FFEA56-2CC6-4B5F-89A0-5E7B8CF0F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7" y="2101"/>
              <a:ext cx="36" cy="36"/>
            </a:xfrm>
            <a:prstGeom prst="ellipse">
              <a:avLst/>
            </a:prstGeom>
            <a:solidFill>
              <a:srgbClr val="FFFFFF"/>
            </a:solidFill>
            <a:ln w="6350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" name="Line 114">
              <a:extLst>
                <a:ext uri="{FF2B5EF4-FFF2-40B4-BE49-F238E27FC236}">
                  <a16:creationId xmlns:a16="http://schemas.microsoft.com/office/drawing/2014/main" id="{E1D9C507-5832-4FF8-AE14-DFA648C08B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5" y="1913"/>
              <a:ext cx="1770" cy="259"/>
            </a:xfrm>
            <a:prstGeom prst="line">
              <a:avLst/>
            </a:prstGeom>
            <a:noFill/>
            <a:ln w="19050">
              <a:solidFill>
                <a:srgbClr val="FF00FF"/>
              </a:solidFill>
              <a:prstDash val="sysDashDot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" name="Freeform 115">
              <a:extLst>
                <a:ext uri="{FF2B5EF4-FFF2-40B4-BE49-F238E27FC236}">
                  <a16:creationId xmlns:a16="http://schemas.microsoft.com/office/drawing/2014/main" id="{D99CBC67-A624-448E-AF45-DD39AAA7F1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5" y="1659"/>
              <a:ext cx="1766" cy="380"/>
            </a:xfrm>
            <a:custGeom>
              <a:avLst/>
              <a:gdLst>
                <a:gd name="T0" fmla="*/ 0 w 1766"/>
                <a:gd name="T1" fmla="*/ 376 h 380"/>
                <a:gd name="T2" fmla="*/ 79 w 1766"/>
                <a:gd name="T3" fmla="*/ 376 h 380"/>
                <a:gd name="T4" fmla="*/ 118 w 1766"/>
                <a:gd name="T5" fmla="*/ 376 h 380"/>
                <a:gd name="T6" fmla="*/ 157 w 1766"/>
                <a:gd name="T7" fmla="*/ 380 h 380"/>
                <a:gd name="T8" fmla="*/ 236 w 1766"/>
                <a:gd name="T9" fmla="*/ 380 h 380"/>
                <a:gd name="T10" fmla="*/ 275 w 1766"/>
                <a:gd name="T11" fmla="*/ 376 h 380"/>
                <a:gd name="T12" fmla="*/ 353 w 1766"/>
                <a:gd name="T13" fmla="*/ 376 h 380"/>
                <a:gd name="T14" fmla="*/ 393 w 1766"/>
                <a:gd name="T15" fmla="*/ 376 h 380"/>
                <a:gd name="T16" fmla="*/ 471 w 1766"/>
                <a:gd name="T17" fmla="*/ 368 h 380"/>
                <a:gd name="T18" fmla="*/ 550 w 1766"/>
                <a:gd name="T19" fmla="*/ 360 h 380"/>
                <a:gd name="T20" fmla="*/ 589 w 1766"/>
                <a:gd name="T21" fmla="*/ 356 h 380"/>
                <a:gd name="T22" fmla="*/ 667 w 1766"/>
                <a:gd name="T23" fmla="*/ 341 h 380"/>
                <a:gd name="T24" fmla="*/ 746 w 1766"/>
                <a:gd name="T25" fmla="*/ 325 h 380"/>
                <a:gd name="T26" fmla="*/ 785 w 1766"/>
                <a:gd name="T27" fmla="*/ 313 h 380"/>
                <a:gd name="T28" fmla="*/ 824 w 1766"/>
                <a:gd name="T29" fmla="*/ 305 h 380"/>
                <a:gd name="T30" fmla="*/ 903 w 1766"/>
                <a:gd name="T31" fmla="*/ 282 h 380"/>
                <a:gd name="T32" fmla="*/ 981 w 1766"/>
                <a:gd name="T33" fmla="*/ 258 h 380"/>
                <a:gd name="T34" fmla="*/ 1060 w 1766"/>
                <a:gd name="T35" fmla="*/ 235 h 380"/>
                <a:gd name="T36" fmla="*/ 1138 w 1766"/>
                <a:gd name="T37" fmla="*/ 211 h 380"/>
                <a:gd name="T38" fmla="*/ 1217 w 1766"/>
                <a:gd name="T39" fmla="*/ 188 h 380"/>
                <a:gd name="T40" fmla="*/ 1256 w 1766"/>
                <a:gd name="T41" fmla="*/ 172 h 380"/>
                <a:gd name="T42" fmla="*/ 1335 w 1766"/>
                <a:gd name="T43" fmla="*/ 149 h 380"/>
                <a:gd name="T44" fmla="*/ 1374 w 1766"/>
                <a:gd name="T45" fmla="*/ 133 h 380"/>
                <a:gd name="T46" fmla="*/ 1452 w 1766"/>
                <a:gd name="T47" fmla="*/ 110 h 380"/>
                <a:gd name="T48" fmla="*/ 1492 w 1766"/>
                <a:gd name="T49" fmla="*/ 94 h 380"/>
                <a:gd name="T50" fmla="*/ 1531 w 1766"/>
                <a:gd name="T51" fmla="*/ 82 h 380"/>
                <a:gd name="T52" fmla="*/ 1570 w 1766"/>
                <a:gd name="T53" fmla="*/ 67 h 380"/>
                <a:gd name="T54" fmla="*/ 1649 w 1766"/>
                <a:gd name="T55" fmla="*/ 43 h 380"/>
                <a:gd name="T56" fmla="*/ 1688 w 1766"/>
                <a:gd name="T57" fmla="*/ 28 h 380"/>
                <a:gd name="T58" fmla="*/ 1727 w 1766"/>
                <a:gd name="T59" fmla="*/ 16 h 380"/>
                <a:gd name="T60" fmla="*/ 1766 w 1766"/>
                <a:gd name="T61" fmla="*/ 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766" h="380">
                  <a:moveTo>
                    <a:pt x="0" y="376"/>
                  </a:moveTo>
                  <a:lnTo>
                    <a:pt x="79" y="376"/>
                  </a:lnTo>
                  <a:lnTo>
                    <a:pt x="118" y="376"/>
                  </a:lnTo>
                  <a:lnTo>
                    <a:pt x="157" y="380"/>
                  </a:lnTo>
                  <a:lnTo>
                    <a:pt x="236" y="380"/>
                  </a:lnTo>
                  <a:lnTo>
                    <a:pt x="275" y="376"/>
                  </a:lnTo>
                  <a:lnTo>
                    <a:pt x="353" y="376"/>
                  </a:lnTo>
                  <a:lnTo>
                    <a:pt x="393" y="376"/>
                  </a:lnTo>
                  <a:lnTo>
                    <a:pt x="471" y="368"/>
                  </a:lnTo>
                  <a:lnTo>
                    <a:pt x="550" y="360"/>
                  </a:lnTo>
                  <a:lnTo>
                    <a:pt x="589" y="356"/>
                  </a:lnTo>
                  <a:lnTo>
                    <a:pt x="667" y="341"/>
                  </a:lnTo>
                  <a:lnTo>
                    <a:pt x="746" y="325"/>
                  </a:lnTo>
                  <a:lnTo>
                    <a:pt x="785" y="313"/>
                  </a:lnTo>
                  <a:lnTo>
                    <a:pt x="824" y="305"/>
                  </a:lnTo>
                  <a:lnTo>
                    <a:pt x="903" y="282"/>
                  </a:lnTo>
                  <a:lnTo>
                    <a:pt x="981" y="258"/>
                  </a:lnTo>
                  <a:lnTo>
                    <a:pt x="1060" y="235"/>
                  </a:lnTo>
                  <a:lnTo>
                    <a:pt x="1138" y="211"/>
                  </a:lnTo>
                  <a:lnTo>
                    <a:pt x="1217" y="188"/>
                  </a:lnTo>
                  <a:lnTo>
                    <a:pt x="1256" y="172"/>
                  </a:lnTo>
                  <a:lnTo>
                    <a:pt x="1335" y="149"/>
                  </a:lnTo>
                  <a:lnTo>
                    <a:pt x="1374" y="133"/>
                  </a:lnTo>
                  <a:lnTo>
                    <a:pt x="1452" y="110"/>
                  </a:lnTo>
                  <a:lnTo>
                    <a:pt x="1492" y="94"/>
                  </a:lnTo>
                  <a:lnTo>
                    <a:pt x="1531" y="82"/>
                  </a:lnTo>
                  <a:lnTo>
                    <a:pt x="1570" y="67"/>
                  </a:lnTo>
                  <a:lnTo>
                    <a:pt x="1649" y="43"/>
                  </a:lnTo>
                  <a:lnTo>
                    <a:pt x="1688" y="28"/>
                  </a:lnTo>
                  <a:lnTo>
                    <a:pt x="1727" y="16"/>
                  </a:lnTo>
                  <a:lnTo>
                    <a:pt x="1766" y="0"/>
                  </a:lnTo>
                </a:path>
              </a:pathLst>
            </a:custGeom>
            <a:noFill/>
            <a:ln w="19050">
              <a:solidFill>
                <a:srgbClr val="FF67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/>
            </a:p>
          </p:txBody>
        </p:sp>
        <p:sp>
          <p:nvSpPr>
            <p:cNvPr id="116" name="Freeform 116">
              <a:extLst>
                <a:ext uri="{FF2B5EF4-FFF2-40B4-BE49-F238E27FC236}">
                  <a16:creationId xmlns:a16="http://schemas.microsoft.com/office/drawing/2014/main" id="{85096445-1EEF-4256-919F-D82850D726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5" y="2140"/>
              <a:ext cx="1766" cy="173"/>
            </a:xfrm>
            <a:custGeom>
              <a:avLst/>
              <a:gdLst>
                <a:gd name="T0" fmla="*/ 0 w 1766"/>
                <a:gd name="T1" fmla="*/ 173 h 173"/>
                <a:gd name="T2" fmla="*/ 39 w 1766"/>
                <a:gd name="T3" fmla="*/ 161 h 173"/>
                <a:gd name="T4" fmla="*/ 79 w 1766"/>
                <a:gd name="T5" fmla="*/ 145 h 173"/>
                <a:gd name="T6" fmla="*/ 157 w 1766"/>
                <a:gd name="T7" fmla="*/ 122 h 173"/>
                <a:gd name="T8" fmla="*/ 236 w 1766"/>
                <a:gd name="T9" fmla="*/ 98 h 173"/>
                <a:gd name="T10" fmla="*/ 275 w 1766"/>
                <a:gd name="T11" fmla="*/ 87 h 173"/>
                <a:gd name="T12" fmla="*/ 314 w 1766"/>
                <a:gd name="T13" fmla="*/ 79 h 173"/>
                <a:gd name="T14" fmla="*/ 353 w 1766"/>
                <a:gd name="T15" fmla="*/ 67 h 173"/>
                <a:gd name="T16" fmla="*/ 393 w 1766"/>
                <a:gd name="T17" fmla="*/ 59 h 173"/>
                <a:gd name="T18" fmla="*/ 432 w 1766"/>
                <a:gd name="T19" fmla="*/ 47 h 173"/>
                <a:gd name="T20" fmla="*/ 510 w 1766"/>
                <a:gd name="T21" fmla="*/ 32 h 173"/>
                <a:gd name="T22" fmla="*/ 550 w 1766"/>
                <a:gd name="T23" fmla="*/ 24 h 173"/>
                <a:gd name="T24" fmla="*/ 628 w 1766"/>
                <a:gd name="T25" fmla="*/ 16 h 173"/>
                <a:gd name="T26" fmla="*/ 667 w 1766"/>
                <a:gd name="T27" fmla="*/ 8 h 173"/>
                <a:gd name="T28" fmla="*/ 707 w 1766"/>
                <a:gd name="T29" fmla="*/ 8 h 173"/>
                <a:gd name="T30" fmla="*/ 785 w 1766"/>
                <a:gd name="T31" fmla="*/ 0 h 173"/>
                <a:gd name="T32" fmla="*/ 864 w 1766"/>
                <a:gd name="T33" fmla="*/ 0 h 173"/>
                <a:gd name="T34" fmla="*/ 942 w 1766"/>
                <a:gd name="T35" fmla="*/ 0 h 173"/>
                <a:gd name="T36" fmla="*/ 1021 w 1766"/>
                <a:gd name="T37" fmla="*/ 0 h 173"/>
                <a:gd name="T38" fmla="*/ 1099 w 1766"/>
                <a:gd name="T39" fmla="*/ 0 h 173"/>
                <a:gd name="T40" fmla="*/ 1138 w 1766"/>
                <a:gd name="T41" fmla="*/ 0 h 173"/>
                <a:gd name="T42" fmla="*/ 1178 w 1766"/>
                <a:gd name="T43" fmla="*/ 4 h 173"/>
                <a:gd name="T44" fmla="*/ 1256 w 1766"/>
                <a:gd name="T45" fmla="*/ 4 h 173"/>
                <a:gd name="T46" fmla="*/ 1295 w 1766"/>
                <a:gd name="T47" fmla="*/ 8 h 173"/>
                <a:gd name="T48" fmla="*/ 1335 w 1766"/>
                <a:gd name="T49" fmla="*/ 8 h 173"/>
                <a:gd name="T50" fmla="*/ 1374 w 1766"/>
                <a:gd name="T51" fmla="*/ 12 h 173"/>
                <a:gd name="T52" fmla="*/ 1452 w 1766"/>
                <a:gd name="T53" fmla="*/ 12 h 173"/>
                <a:gd name="T54" fmla="*/ 1492 w 1766"/>
                <a:gd name="T55" fmla="*/ 16 h 173"/>
                <a:gd name="T56" fmla="*/ 1531 w 1766"/>
                <a:gd name="T57" fmla="*/ 16 h 173"/>
                <a:gd name="T58" fmla="*/ 1570 w 1766"/>
                <a:gd name="T59" fmla="*/ 20 h 173"/>
                <a:gd name="T60" fmla="*/ 1609 w 1766"/>
                <a:gd name="T61" fmla="*/ 20 h 173"/>
                <a:gd name="T62" fmla="*/ 1649 w 1766"/>
                <a:gd name="T63" fmla="*/ 24 h 173"/>
                <a:gd name="T64" fmla="*/ 1688 w 1766"/>
                <a:gd name="T65" fmla="*/ 24 h 173"/>
                <a:gd name="T66" fmla="*/ 1727 w 1766"/>
                <a:gd name="T67" fmla="*/ 28 h 173"/>
                <a:gd name="T68" fmla="*/ 1766 w 1766"/>
                <a:gd name="T69" fmla="*/ 28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766" h="173">
                  <a:moveTo>
                    <a:pt x="0" y="173"/>
                  </a:moveTo>
                  <a:lnTo>
                    <a:pt x="39" y="161"/>
                  </a:lnTo>
                  <a:lnTo>
                    <a:pt x="79" y="145"/>
                  </a:lnTo>
                  <a:lnTo>
                    <a:pt x="157" y="122"/>
                  </a:lnTo>
                  <a:lnTo>
                    <a:pt x="236" y="98"/>
                  </a:lnTo>
                  <a:lnTo>
                    <a:pt x="275" y="87"/>
                  </a:lnTo>
                  <a:lnTo>
                    <a:pt x="314" y="79"/>
                  </a:lnTo>
                  <a:lnTo>
                    <a:pt x="353" y="67"/>
                  </a:lnTo>
                  <a:lnTo>
                    <a:pt x="393" y="59"/>
                  </a:lnTo>
                  <a:lnTo>
                    <a:pt x="432" y="47"/>
                  </a:lnTo>
                  <a:lnTo>
                    <a:pt x="510" y="32"/>
                  </a:lnTo>
                  <a:lnTo>
                    <a:pt x="550" y="24"/>
                  </a:lnTo>
                  <a:lnTo>
                    <a:pt x="628" y="16"/>
                  </a:lnTo>
                  <a:lnTo>
                    <a:pt x="667" y="8"/>
                  </a:lnTo>
                  <a:lnTo>
                    <a:pt x="707" y="8"/>
                  </a:lnTo>
                  <a:lnTo>
                    <a:pt x="785" y="0"/>
                  </a:lnTo>
                  <a:lnTo>
                    <a:pt x="864" y="0"/>
                  </a:lnTo>
                  <a:lnTo>
                    <a:pt x="942" y="0"/>
                  </a:lnTo>
                  <a:lnTo>
                    <a:pt x="1021" y="0"/>
                  </a:lnTo>
                  <a:lnTo>
                    <a:pt x="1099" y="0"/>
                  </a:lnTo>
                  <a:lnTo>
                    <a:pt x="1138" y="0"/>
                  </a:lnTo>
                  <a:lnTo>
                    <a:pt x="1178" y="4"/>
                  </a:lnTo>
                  <a:lnTo>
                    <a:pt x="1256" y="4"/>
                  </a:lnTo>
                  <a:lnTo>
                    <a:pt x="1295" y="8"/>
                  </a:lnTo>
                  <a:lnTo>
                    <a:pt x="1335" y="8"/>
                  </a:lnTo>
                  <a:lnTo>
                    <a:pt x="1374" y="12"/>
                  </a:lnTo>
                  <a:lnTo>
                    <a:pt x="1452" y="12"/>
                  </a:lnTo>
                  <a:lnTo>
                    <a:pt x="1492" y="16"/>
                  </a:lnTo>
                  <a:lnTo>
                    <a:pt x="1531" y="16"/>
                  </a:lnTo>
                  <a:lnTo>
                    <a:pt x="1570" y="20"/>
                  </a:lnTo>
                  <a:lnTo>
                    <a:pt x="1609" y="20"/>
                  </a:lnTo>
                  <a:lnTo>
                    <a:pt x="1649" y="24"/>
                  </a:lnTo>
                  <a:lnTo>
                    <a:pt x="1688" y="24"/>
                  </a:lnTo>
                  <a:lnTo>
                    <a:pt x="1727" y="28"/>
                  </a:lnTo>
                  <a:lnTo>
                    <a:pt x="1766" y="28"/>
                  </a:lnTo>
                </a:path>
              </a:pathLst>
            </a:custGeom>
            <a:noFill/>
            <a:ln w="19050">
              <a:solidFill>
                <a:srgbClr val="FF67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" name="Line 117">
              <a:extLst>
                <a:ext uri="{FF2B5EF4-FFF2-40B4-BE49-F238E27FC236}">
                  <a16:creationId xmlns:a16="http://schemas.microsoft.com/office/drawing/2014/main" id="{7AF22206-8F8B-40BF-BE3C-C88EB97B5F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2" y="2090"/>
              <a:ext cx="2398" cy="0"/>
            </a:xfrm>
            <a:prstGeom prst="line">
              <a:avLst/>
            </a:prstGeom>
            <a:noFill/>
            <a:ln w="19050">
              <a:solidFill>
                <a:srgbClr val="3333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" name="Rectangle 118">
              <a:extLst>
                <a:ext uri="{FF2B5EF4-FFF2-40B4-BE49-F238E27FC236}">
                  <a16:creationId xmlns:a16="http://schemas.microsoft.com/office/drawing/2014/main" id="{CB5CFDC1-DA87-4238-8ED7-162DA71AA6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0" y="1958"/>
              <a:ext cx="18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 err="1">
                  <a:ln>
                    <a:noFill/>
                  </a:ln>
                  <a:effectLst/>
                  <a:cs typeface="Arial" panose="020B0604020202020204" pitchFamily="34" charset="0"/>
                </a:rPr>
                <a:t>Mean</a:t>
              </a:r>
              <a:endParaRPr kumimoji="0" lang="ko-KR" altLang="ko-KR" sz="14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9" name="Rectangle 119">
              <a:extLst>
                <a:ext uri="{FF2B5EF4-FFF2-40B4-BE49-F238E27FC236}">
                  <a16:creationId xmlns:a16="http://schemas.microsoft.com/office/drawing/2014/main" id="{41BBEE0D-C482-49C3-B036-2C6C257C5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1" y="2128"/>
              <a:ext cx="146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41.9</a:t>
              </a:r>
            </a:p>
          </p:txBody>
        </p:sp>
        <p:sp>
          <p:nvSpPr>
            <p:cNvPr id="120" name="Line 120">
              <a:extLst>
                <a:ext uri="{FF2B5EF4-FFF2-40B4-BE49-F238E27FC236}">
                  <a16:creationId xmlns:a16="http://schemas.microsoft.com/office/drawing/2014/main" id="{EBE0B161-5314-45E5-A723-E53084291A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2" y="2657"/>
              <a:ext cx="239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" name="Rectangle 121">
              <a:extLst>
                <a:ext uri="{FF2B5EF4-FFF2-40B4-BE49-F238E27FC236}">
                  <a16:creationId xmlns:a16="http://schemas.microsoft.com/office/drawing/2014/main" id="{03EDABAA-0657-4516-9B52-B23AB541F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6" y="2535"/>
              <a:ext cx="297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-1.96 SD</a:t>
              </a:r>
            </a:p>
          </p:txBody>
        </p:sp>
        <p:sp>
          <p:nvSpPr>
            <p:cNvPr id="122" name="Rectangle 122">
              <a:extLst>
                <a:ext uri="{FF2B5EF4-FFF2-40B4-BE49-F238E27FC236}">
                  <a16:creationId xmlns:a16="http://schemas.microsoft.com/office/drawing/2014/main" id="{EB8927BF-E7A2-4135-B4E1-FCAC24A39F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1" y="2693"/>
              <a:ext cx="171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-16.5</a:t>
              </a:r>
            </a:p>
          </p:txBody>
        </p:sp>
        <p:sp>
          <p:nvSpPr>
            <p:cNvPr id="123" name="Line 123">
              <a:extLst>
                <a:ext uri="{FF2B5EF4-FFF2-40B4-BE49-F238E27FC236}">
                  <a16:creationId xmlns:a16="http://schemas.microsoft.com/office/drawing/2014/main" id="{DC008019-C026-4091-B92B-F115A44DA7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2" y="1518"/>
              <a:ext cx="2398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dirty="0"/>
            </a:p>
          </p:txBody>
        </p:sp>
        <p:sp>
          <p:nvSpPr>
            <p:cNvPr id="124" name="Rectangle 124">
              <a:extLst>
                <a:ext uri="{FF2B5EF4-FFF2-40B4-BE49-F238E27FC236}">
                  <a16:creationId xmlns:a16="http://schemas.microsoft.com/office/drawing/2014/main" id="{9F40EA89-1B76-4E74-A79F-8E85795773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5" y="1397"/>
              <a:ext cx="316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+1.96 SD</a:t>
              </a:r>
            </a:p>
          </p:txBody>
        </p:sp>
        <p:sp>
          <p:nvSpPr>
            <p:cNvPr id="125" name="Rectangle 125">
              <a:extLst>
                <a:ext uri="{FF2B5EF4-FFF2-40B4-BE49-F238E27FC236}">
                  <a16:creationId xmlns:a16="http://schemas.microsoft.com/office/drawing/2014/main" id="{512AEDAB-A0B8-48B4-8E7E-AA376897C6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" y="1554"/>
              <a:ext cx="18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4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100.4</a:t>
              </a:r>
            </a:p>
          </p:txBody>
        </p:sp>
      </p:grpSp>
      <p:sp>
        <p:nvSpPr>
          <p:cNvPr id="126" name="TextBox 125">
            <a:extLst>
              <a:ext uri="{FF2B5EF4-FFF2-40B4-BE49-F238E27FC236}">
                <a16:creationId xmlns:a16="http://schemas.microsoft.com/office/drawing/2014/main" id="{05FF2F9F-9AB1-4178-9202-B8BE1FFA46F5}"/>
              </a:ext>
            </a:extLst>
          </p:cNvPr>
          <p:cNvSpPr txBox="1"/>
          <p:nvPr/>
        </p:nvSpPr>
        <p:spPr>
          <a:xfrm>
            <a:off x="14763" y="9606"/>
            <a:ext cx="265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59538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EB994C78-770C-4F3D-AF9B-2C86806C80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832730"/>
              </p:ext>
            </p:extLst>
          </p:nvPr>
        </p:nvGraphicFramePr>
        <p:xfrm>
          <a:off x="1421320" y="1488376"/>
          <a:ext cx="6213240" cy="3929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5" r:id="rId3" imgW="4142160" imgH="2619720" progId="Prism5.Document">
                  <p:embed/>
                </p:oleObj>
              </mc:Choice>
              <mc:Fallback>
                <p:oleObj name="Prism 5" r:id="rId3" imgW="4142160" imgH="2619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21320" y="1488376"/>
                        <a:ext cx="6213240" cy="3929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7011245-C1A3-4715-9BD8-B26DA3F98B5E}"/>
              </a:ext>
            </a:extLst>
          </p:cNvPr>
          <p:cNvSpPr txBox="1"/>
          <p:nvPr/>
        </p:nvSpPr>
        <p:spPr>
          <a:xfrm>
            <a:off x="14763" y="9606"/>
            <a:ext cx="265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Supplementary figure 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64175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44</Words>
  <Application>Microsoft Office PowerPoint</Application>
  <PresentationFormat>화면 슬라이드 쇼(4:3)</PresentationFormat>
  <Paragraphs>20</Paragraphs>
  <Slides>2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GraphPad Prism 5 Project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nigma1012.hwang@gmail.com</dc:creator>
  <cp:lastModifiedBy>enigma1012.hwang@gmail.com</cp:lastModifiedBy>
  <cp:revision>5</cp:revision>
  <dcterms:created xsi:type="dcterms:W3CDTF">2017-07-29T03:06:28Z</dcterms:created>
  <dcterms:modified xsi:type="dcterms:W3CDTF">2017-08-08T10:27:27Z</dcterms:modified>
</cp:coreProperties>
</file>